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082E6701-5F1D-4EAA-B0F3-010467984C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64356" y="3602038"/>
            <a:ext cx="11451432" cy="52209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Forest plot of baseline serum potassium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82010E02-AF90-220F-AE17-6AB395F8BD19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52625" y="870857"/>
            <a:ext cx="8286750" cy="2310493"/>
            <a:chOff x="1230" y="750"/>
            <a:chExt cx="5220" cy="1254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6682B426-7E1C-5A9D-D0DA-F35003136D2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30" y="750"/>
              <a:ext cx="5220" cy="1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CE4003FB-A1D3-30DA-E257-1C865F7BD6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" y="750"/>
              <a:ext cx="5220" cy="125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175F8394-36F0-FE07-EF2B-532C3B955D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0" y="943"/>
              <a:ext cx="522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0E2F0687-F222-ED88-6944-F3BA2F01F7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870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D6B04D3B-A20A-5288-9FA2-082EFBBE0C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977"/>
              <a:ext cx="3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n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47BB8312-DFB2-DA51-B493-F78FF5FFD0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073"/>
              <a:ext cx="3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EB4F3154-FE4D-D6C2-23A6-B7926C87D6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170"/>
              <a:ext cx="32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 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7001522B-5C4D-D015-73BB-6E47080ECA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266"/>
              <a:ext cx="41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lib 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69B3C18E-7D8D-3367-0FFC-0A3EB6B815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363"/>
              <a:ext cx="30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49F66EA2-8DB5-AB33-F24C-937D1978B8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459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EA6DF442-59FE-5692-F278-33541EBFAF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642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057830BF-3E9D-ABA1-5A9C-D9AEBC471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747"/>
              <a:ext cx="191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5.63, df = 5 (P = 0.34); I² = 1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2E0F0244-BECD-39A1-AFEE-46AE39AA20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0" y="1845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1.07 (P = 0.28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8B4A3970-A174-99E3-00D0-AE812E11F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3" y="870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0F12C1A7-3E53-7A98-0329-47E1B43DE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97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6FA82627-3D46-D060-05A6-3ED4F259F5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107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C56F6F51-F4B3-E1C7-FFDF-51031078F2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117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6E779025-ADAC-1831-1F28-350D1E03A4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12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4ED6068B-0ECF-068F-B390-D148B71517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13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8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F9D8FD67-3061-79C5-0218-D2547B7CF0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9" y="1459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D985B1B3-D38A-EFF8-692E-F675F1B9E4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1" y="870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42BBF3D8-A2D8-C42B-76F7-73AB716993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" y="97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5AB8BE5F-305D-C6C9-56B1-C4C21212D7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" y="1073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293207C6-F860-8D49-DEAE-4160667376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" y="117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372E873B-3847-5964-965B-76C8D8659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7" y="1266"/>
              <a:ext cx="14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C2397116-AF95-5F15-610D-C81529F401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" y="13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12404FC4-8144-3F4F-682C-74C73D892C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" y="1459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EDAE02AF-0BCD-A3E5-0950-F36A1A3B8A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7" y="870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BC401CC0-BA44-217C-DC2A-716E17E0D3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977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588383D0-5056-D801-B9DB-F005717489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1073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7306AEFD-D233-D4A7-BC25-46C449B3D5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5" y="117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EFD49508-FBEB-F57B-F05D-7CA1C7A7E9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1266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C8827AB5-CC22-5740-9FB3-68770E39D9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1363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630E1C32-6DA3-8E3F-25B8-388B4826DF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" y="1459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8BBF9635-DB43-A78F-A327-AC484484D4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0" y="1642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62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2617CC8D-C85A-D05E-A0D9-D7DAD55E91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0" y="870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82BF47B4-5C02-9D32-D90A-EB8AA823D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977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6A0B0F97-E061-9EE9-7FB1-83DDA54863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107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A7E00F5E-2FD6-817A-1154-F7CCDA1F9F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6" y="1170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72D814EC-8A92-D782-23C6-B0891E440A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12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76CA6736-D856-4240-1A4C-B9468CB02B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1363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F42284F8-5841-ADF0-C593-BB464CB241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" y="1459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0F2FE3A4-12FC-51CE-8817-9CF6C66B2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" y="870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D40D023B-0229-EB68-6BEB-DB1E0A12B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97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E5567867-B936-8AF2-B329-038FE5A304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107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1BB08B46-40A9-9590-A7EC-83D2001CB6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117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04C087F8-7567-B190-24FF-0C29078A93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12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C20D430C-12F6-FA24-7EFF-0F51C7F072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13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F6FCB2A1-B3C9-67C8-9526-90CDB03DE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" y="1459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A01668A8-3DDA-A6BF-595D-74EA5CA024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6" y="870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8E959067-1149-37C3-C9C1-FE089DFF23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4" y="977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2639276D-A1D6-67DB-24FA-E5DE1C824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4" y="1073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447855ED-ADF4-12AA-8AC2-CD2A6AADFE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17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5742778A-A5FF-7D88-032E-803523034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4" y="126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D515FB70-636E-7EAA-D6C7-A24BAA2D2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36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60E2D445-9543-732F-D071-6D3032123E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459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C645EAF4-D9A5-FD35-FCE5-81F8B9E26C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1642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83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0817A3C8-2F05-75DC-A345-A7000DB10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" y="870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414C0057-2D33-7CEB-B627-8F3089B976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0" y="977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.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4F646BE8-76B6-C6BD-359B-48764F82C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1" y="1073"/>
              <a:ext cx="21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6BE1F520-501C-DF17-936B-5C6F40C0B4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0" y="117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1.8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E60F7DCE-BCEA-1B07-807B-D1552EA53F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1" y="1266"/>
              <a:ext cx="21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C1415D8F-9E39-39CE-D106-26E803E56B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1" y="1363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EB8A295B-DE00-2027-68D6-3B47EBFC5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0" y="1459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C8BBBD4D-C8CA-7DEB-6BB3-5AAC0E3FDC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" y="1642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C40279F8-06DD-1501-341B-460C3A133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3" y="870"/>
              <a:ext cx="60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577214D4-B5A5-A8FA-87E6-1858CD6D51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" y="977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07, 0.05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0238ED88-1949-5BDA-97FB-28B563D9A7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" y="1073"/>
              <a:ext cx="6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18, 0.1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9419AB69-337A-1F1C-BA1D-E7A567F3BD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" y="1170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07, 0.05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2B1BEDBD-1B42-43E6-3EBE-CF2DB6EBF1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" y="1266"/>
              <a:ext cx="6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3 [-0.26, 0.20]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806E4CE1-9618-3FE4-8AEA-956127CF7D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1" y="1363"/>
              <a:ext cx="62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8 [-0.50, -0.0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4101B737-8627-9D6F-48BC-E773D4E077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" y="1459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3 [-0.15, 0.0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6B2797F7-EB22-EC3D-983B-7F69DBF209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1" y="1642"/>
              <a:ext cx="6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-0.02 [-0.06, 0.0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8C65C5C3-1C5B-1CA5-9253-B261C5781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5" y="773"/>
              <a:ext cx="44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DDE840AC-32AB-6ED2-689F-DA046DC64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" y="773"/>
              <a:ext cx="62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3E91163C-1484-9906-21FE-B422145868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0" y="773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B2F4E076-C476-D75F-ADC5-C32C0D971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1" y="773"/>
              <a:ext cx="655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3DA943D4-1CC8-B957-5206-3D3EE58140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0" y="870"/>
              <a:ext cx="6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6FF50D35-466A-2CEB-346A-C5803675C3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84" y="943"/>
              <a:ext cx="0" cy="82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Line 83">
              <a:extLst>
                <a:ext uri="{FF2B5EF4-FFF2-40B4-BE49-F238E27FC236}">
                  <a16:creationId xmlns:a16="http://schemas.microsoft.com/office/drawing/2014/main" id="{D8ABDC8F-3713-9507-A74C-D09E5B823D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6" y="991"/>
              <a:ext cx="185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7923A5CB-3C43-C4C6-5D6F-FEAA65504A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5" y="973"/>
              <a:ext cx="48" cy="4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Line 85">
              <a:extLst>
                <a:ext uri="{FF2B5EF4-FFF2-40B4-BE49-F238E27FC236}">
                  <a16:creationId xmlns:a16="http://schemas.microsoft.com/office/drawing/2014/main" id="{74F4F2B5-8E2D-63B7-13B3-AD2409CAA1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8" y="1088"/>
              <a:ext cx="50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5064C76E-62F7-C0A1-3CAC-87B1874BDD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0" y="1085"/>
              <a:ext cx="17" cy="1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id="{2F126E3A-0AFD-EA1E-B02D-4BC07424B5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2" y="1184"/>
              <a:ext cx="17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id="{079E6F0E-49E0-7083-6B65-76C2331785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3" y="1164"/>
              <a:ext cx="52" cy="52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Line 89">
              <a:extLst>
                <a:ext uri="{FF2B5EF4-FFF2-40B4-BE49-F238E27FC236}">
                  <a16:creationId xmlns:a16="http://schemas.microsoft.com/office/drawing/2014/main" id="{E302E007-4B8E-FCE0-D32B-D17583DE22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8" y="1281"/>
              <a:ext cx="68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623F412E-C21D-D589-733E-6CC2AEA3FF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2" y="1279"/>
              <a:ext cx="14" cy="15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Line 91">
              <a:extLst>
                <a:ext uri="{FF2B5EF4-FFF2-40B4-BE49-F238E27FC236}">
                  <a16:creationId xmlns:a16="http://schemas.microsoft.com/office/drawing/2014/main" id="{BA56ACE6-225E-36D4-D17D-96E827E0E9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7" y="1377"/>
              <a:ext cx="65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Rectangle 92">
              <a:extLst>
                <a:ext uri="{FF2B5EF4-FFF2-40B4-BE49-F238E27FC236}">
                  <a16:creationId xmlns:a16="http://schemas.microsoft.com/office/drawing/2014/main" id="{BBDCA39E-050E-C72E-B30E-F21CF11C0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8" y="1376"/>
              <a:ext cx="15" cy="1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Line 93">
              <a:extLst>
                <a:ext uri="{FF2B5EF4-FFF2-40B4-BE49-F238E27FC236}">
                  <a16:creationId xmlns:a16="http://schemas.microsoft.com/office/drawing/2014/main" id="{204BC739-CE28-91AF-BDC9-E43A46F2C1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6" y="1473"/>
              <a:ext cx="34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Rectangle 94">
              <a:extLst>
                <a:ext uri="{FF2B5EF4-FFF2-40B4-BE49-F238E27FC236}">
                  <a16:creationId xmlns:a16="http://schemas.microsoft.com/office/drawing/2014/main" id="{5DAA3402-0D9C-1332-A2FB-6B42893A2C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8" y="1468"/>
              <a:ext cx="22" cy="2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Freeform 95">
              <a:extLst>
                <a:ext uri="{FF2B5EF4-FFF2-40B4-BE49-F238E27FC236}">
                  <a16:creationId xmlns:a16="http://schemas.microsoft.com/office/drawing/2014/main" id="{F52CB268-5EB8-AE86-977B-04F44788009D}"/>
                </a:ext>
              </a:extLst>
            </p:cNvPr>
            <p:cNvSpPr>
              <a:spLocks/>
            </p:cNvSpPr>
            <p:nvPr/>
          </p:nvSpPr>
          <p:spPr bwMode="auto">
            <a:xfrm>
              <a:off x="5297" y="1624"/>
              <a:ext cx="108" cy="85"/>
            </a:xfrm>
            <a:custGeom>
              <a:avLst/>
              <a:gdLst>
                <a:gd name="T0" fmla="*/ 180 w 360"/>
                <a:gd name="T1" fmla="*/ 280 h 280"/>
                <a:gd name="T2" fmla="*/ 0 w 360"/>
                <a:gd name="T3" fmla="*/ 140 h 280"/>
                <a:gd name="T4" fmla="*/ 180 w 360"/>
                <a:gd name="T5" fmla="*/ 0 h 280"/>
                <a:gd name="T6" fmla="*/ 360 w 360"/>
                <a:gd name="T7" fmla="*/ 140 h 280"/>
                <a:gd name="T8" fmla="*/ 180 w 36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60" h="280">
                  <a:moveTo>
                    <a:pt x="180" y="280"/>
                  </a:moveTo>
                  <a:lnTo>
                    <a:pt x="0" y="140"/>
                  </a:lnTo>
                  <a:lnTo>
                    <a:pt x="180" y="0"/>
                  </a:lnTo>
                  <a:lnTo>
                    <a:pt x="360" y="140"/>
                  </a:lnTo>
                  <a:lnTo>
                    <a:pt x="18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3C13B850-1208-F573-5295-0B24EFEBF1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4" y="1763"/>
              <a:ext cx="20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Line 97">
              <a:extLst>
                <a:ext uri="{FF2B5EF4-FFF2-40B4-BE49-F238E27FC236}">
                  <a16:creationId xmlns:a16="http://schemas.microsoft.com/office/drawing/2014/main" id="{3BA98777-E060-782C-0377-7B56696785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7" y="1739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C69A2672-469A-D838-DA74-DFFFDF5CD0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5" y="1797"/>
              <a:ext cx="15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99">
              <a:extLst>
                <a:ext uri="{FF2B5EF4-FFF2-40B4-BE49-F238E27FC236}">
                  <a16:creationId xmlns:a16="http://schemas.microsoft.com/office/drawing/2014/main" id="{3D103410-B3F8-8C40-40FA-92978D5DBB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10" y="1739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" name="Rectangle 100">
              <a:extLst>
                <a:ext uri="{FF2B5EF4-FFF2-40B4-BE49-F238E27FC236}">
                  <a16:creationId xmlns:a16="http://schemas.microsoft.com/office/drawing/2014/main" id="{157C0CB5-FA05-1916-BEDF-AA5298EAF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8" y="1797"/>
              <a:ext cx="1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101">
              <a:extLst>
                <a:ext uri="{FF2B5EF4-FFF2-40B4-BE49-F238E27FC236}">
                  <a16:creationId xmlns:a16="http://schemas.microsoft.com/office/drawing/2014/main" id="{D1121F25-BA29-B122-BDD1-F577BC1D0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84" y="1739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Rectangle 102">
              <a:extLst>
                <a:ext uri="{FF2B5EF4-FFF2-40B4-BE49-F238E27FC236}">
                  <a16:creationId xmlns:a16="http://schemas.microsoft.com/office/drawing/2014/main" id="{797EC52E-A876-37A6-3C0F-7002C45EE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4" y="1797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103">
              <a:extLst>
                <a:ext uri="{FF2B5EF4-FFF2-40B4-BE49-F238E27FC236}">
                  <a16:creationId xmlns:a16="http://schemas.microsoft.com/office/drawing/2014/main" id="{A3CF0258-0CCD-7A53-353E-5EDD49D7AC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7" y="1739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9BDB1276-1EF0-8538-16A4-1D081526FA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7" y="179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105">
              <a:extLst>
                <a:ext uri="{FF2B5EF4-FFF2-40B4-BE49-F238E27FC236}">
                  <a16:creationId xmlns:a16="http://schemas.microsoft.com/office/drawing/2014/main" id="{93A7FA16-0B05-CBA2-9E32-0F92FAD136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0" y="1739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3D99F39D-A791-4318-484E-C85CE6EADF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0" y="1797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32A97AA0-5540-F511-CA91-AC62533BD3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1" y="1885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F5000005-A871-6169-7F8D-C6FF44984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4" y="1885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31397499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5</Words>
  <Application>Microsoft Office PowerPoint</Application>
  <PresentationFormat>宽屏</PresentationFormat>
  <Paragraphs>8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6</cp:revision>
  <dcterms:created xsi:type="dcterms:W3CDTF">2023-08-09T12:44:00Z</dcterms:created>
  <dcterms:modified xsi:type="dcterms:W3CDTF">2026-02-06T15:58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